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21674138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50" d="100"/>
          <a:sy n="50" d="100"/>
        </p:scale>
        <p:origin x="1416" y="-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547135"/>
            <a:ext cx="10363200" cy="754581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1383941"/>
            <a:ext cx="9144000" cy="523289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54904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681670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153947"/>
            <a:ext cx="2628900" cy="18367830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153947"/>
            <a:ext cx="7734300" cy="18367830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10627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87666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5403489"/>
            <a:ext cx="10515600" cy="901583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4504620"/>
            <a:ext cx="10515600" cy="474121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08106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769736"/>
            <a:ext cx="5181600" cy="13752041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769736"/>
            <a:ext cx="5181600" cy="13752041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792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153952"/>
            <a:ext cx="10515600" cy="4189331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5313176"/>
            <a:ext cx="5157787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917081"/>
            <a:ext cx="5157787" cy="11644834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5313176"/>
            <a:ext cx="5183188" cy="260390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917081"/>
            <a:ext cx="5183188" cy="11644834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81426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12469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30341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3120679"/>
            <a:ext cx="6172200" cy="1540268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54123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444942"/>
            <a:ext cx="3932237" cy="505729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3120679"/>
            <a:ext cx="6172200" cy="1540268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6502241"/>
            <a:ext cx="3932237" cy="1204620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52098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153952"/>
            <a:ext cx="10515600" cy="418933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769736"/>
            <a:ext cx="10515600" cy="137520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9CC99-E02F-478B-BDAB-38973E193090}" type="datetimeFigureOut">
              <a:rPr lang="pt-BR" smtClean="0"/>
              <a:t>28/06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20088720"/>
            <a:ext cx="41148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20088720"/>
            <a:ext cx="2743200" cy="11539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DE2E55-3CE4-479D-B2E1-972A4AF765A2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91630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6259264" y="15488852"/>
            <a:ext cx="5431658" cy="875097"/>
          </a:xfrm>
        </p:spPr>
        <p:txBody>
          <a:bodyPr>
            <a:noAutofit/>
          </a:bodyPr>
          <a:lstStyle/>
          <a:p>
            <a:pPr algn="r"/>
            <a:r>
              <a:rPr lang="pt-BR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pt-BR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pt-BR" sz="2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8" name="Grupo 77"/>
          <p:cNvGrpSpPr/>
          <p:nvPr/>
        </p:nvGrpSpPr>
        <p:grpSpPr>
          <a:xfrm>
            <a:off x="188868" y="3050392"/>
            <a:ext cx="11802392" cy="8935039"/>
            <a:chOff x="112668" y="7317592"/>
            <a:chExt cx="11802392" cy="8935039"/>
          </a:xfrm>
        </p:grpSpPr>
        <p:sp>
          <p:nvSpPr>
            <p:cNvPr id="4" name="CaixaDeTexto 3"/>
            <p:cNvSpPr txBox="1"/>
            <p:nvPr/>
          </p:nvSpPr>
          <p:spPr>
            <a:xfrm>
              <a:off x="5184233" y="7317592"/>
              <a:ext cx="1997663" cy="334707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al Design</a:t>
              </a:r>
            </a:p>
          </p:txBody>
        </p:sp>
        <p:sp>
          <p:nvSpPr>
            <p:cNvPr id="5" name="CaixaDeTexto 4"/>
            <p:cNvSpPr txBox="1"/>
            <p:nvPr/>
          </p:nvSpPr>
          <p:spPr>
            <a:xfrm>
              <a:off x="652090" y="8283020"/>
              <a:ext cx="4573368" cy="577081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valuation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g-(1-7) </a:t>
              </a:r>
              <a:r>
                <a:rPr lang="pt-BR" sz="1575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</a:t>
              </a:r>
              <a:r>
                <a:rPr lang="pt-BR" sz="1575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-779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voked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sponses</a:t>
              </a:r>
            </a:p>
            <a:p>
              <a:pPr algn="ctr"/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o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</a:t>
              </a:r>
            </a:p>
          </p:txBody>
        </p:sp>
        <p:sp>
          <p:nvSpPr>
            <p:cNvPr id="6" name="CaixaDeTexto 5"/>
            <p:cNvSpPr txBox="1"/>
            <p:nvPr/>
          </p:nvSpPr>
          <p:spPr>
            <a:xfrm>
              <a:off x="7151424" y="8266978"/>
              <a:ext cx="4496552" cy="577081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as receptor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pt-BR" sz="157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-2 in </a:t>
              </a:r>
              <a:r>
                <a:rPr lang="pt-BR" sz="1575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75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 </a:t>
              </a:r>
              <a:r>
                <a:rPr lang="pt-BR" sz="1575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eurons</a:t>
              </a:r>
              <a:endParaRPr lang="pt-BR" sz="157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CaixaDeTexto 6"/>
            <p:cNvSpPr txBox="1"/>
            <p:nvPr/>
          </p:nvSpPr>
          <p:spPr>
            <a:xfrm>
              <a:off x="512846" y="9112730"/>
              <a:ext cx="4920258" cy="334707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ereotaxic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rgery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uid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nnula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o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ilaterally</a:t>
              </a:r>
              <a:endParaRPr lang="pt-BR" sz="15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CaixaDeTexto 7"/>
            <p:cNvSpPr txBox="1"/>
            <p:nvPr/>
          </p:nvSpPr>
          <p:spPr>
            <a:xfrm>
              <a:off x="596626" y="9848867"/>
              <a:ext cx="4684296" cy="577081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nnulation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emoral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rtery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ein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renal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rob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</a:t>
              </a:r>
            </a:p>
            <a:p>
              <a:pPr algn="ctr"/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nnulation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rinary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ladder</a:t>
              </a:r>
              <a:endParaRPr lang="pt-BR" sz="15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>
              <a:off x="1027300" y="10851994"/>
              <a:ext cx="4004366" cy="577081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aselin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AP, MAP, HR, RC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P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cordings</a:t>
              </a:r>
              <a:endParaRPr lang="pt-BR" sz="15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15 min</a:t>
              </a:r>
            </a:p>
          </p:txBody>
        </p:sp>
        <p:sp>
          <p:nvSpPr>
            <p:cNvPr id="10" name="CaixaDeTexto 9"/>
            <p:cNvSpPr txBox="1"/>
            <p:nvPr/>
          </p:nvSpPr>
          <p:spPr>
            <a:xfrm>
              <a:off x="112668" y="12066639"/>
              <a:ext cx="2025619" cy="577081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-(1-7)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r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aline</a:t>
              </a:r>
            </a:p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ilateral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o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</a:t>
              </a:r>
            </a:p>
          </p:txBody>
        </p:sp>
        <p:sp>
          <p:nvSpPr>
            <p:cNvPr id="11" name="CaixaDeTexto 10"/>
            <p:cNvSpPr txBox="1"/>
            <p:nvPr/>
          </p:nvSpPr>
          <p:spPr>
            <a:xfrm>
              <a:off x="2262872" y="12037530"/>
              <a:ext cx="1719022" cy="819455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-779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r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aline</a:t>
              </a:r>
            </a:p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unilateral </a:t>
              </a:r>
              <a:r>
                <a:rPr lang="pt-BR" sz="1575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o</a:t>
              </a:r>
              <a:r>
                <a:rPr lang="pt-BR" sz="157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</a:t>
              </a:r>
            </a:p>
          </p:txBody>
        </p:sp>
        <p:sp>
          <p:nvSpPr>
            <p:cNvPr id="12" name="CaixaDeTexto 11"/>
            <p:cNvSpPr txBox="1"/>
            <p:nvPr/>
          </p:nvSpPr>
          <p:spPr>
            <a:xfrm>
              <a:off x="4141074" y="12019815"/>
              <a:ext cx="2197205" cy="819455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-779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r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aline</a:t>
              </a:r>
            </a:p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ilateral </a:t>
              </a:r>
              <a:r>
                <a:rPr lang="pt-BR" sz="1575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o</a:t>
              </a:r>
              <a:r>
                <a:rPr lang="pt-BR" sz="157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A +</a:t>
              </a:r>
              <a:endParaRPr lang="pt-BR" sz="15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7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-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pt-BR" sz="157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7)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o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</a:t>
              </a:r>
            </a:p>
          </p:txBody>
        </p:sp>
        <p:sp>
          <p:nvSpPr>
            <p:cNvPr id="13" name="CaixaDeTexto 12"/>
            <p:cNvSpPr txBox="1"/>
            <p:nvPr/>
          </p:nvSpPr>
          <p:spPr>
            <a:xfrm>
              <a:off x="1585571" y="13596240"/>
              <a:ext cx="3257367" cy="577081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P, MAP, HR, RC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P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cordings</a:t>
              </a:r>
              <a:endParaRPr lang="pt-BR" sz="15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dditional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pt-BR" sz="1575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 </a:t>
              </a:r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n</a:t>
              </a:r>
            </a:p>
          </p:txBody>
        </p:sp>
        <p:cxnSp>
          <p:nvCxnSpPr>
            <p:cNvPr id="15" name="Conector de seta reta 14"/>
            <p:cNvCxnSpPr>
              <a:stCxn id="8" idx="2"/>
            </p:cNvCxnSpPr>
            <p:nvPr/>
          </p:nvCxnSpPr>
          <p:spPr>
            <a:xfrm>
              <a:off x="2938774" y="10425948"/>
              <a:ext cx="1" cy="396653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ctor de seta reta 16"/>
            <p:cNvCxnSpPr/>
            <p:nvPr/>
          </p:nvCxnSpPr>
          <p:spPr>
            <a:xfrm flipH="1">
              <a:off x="2938773" y="9409441"/>
              <a:ext cx="1" cy="437036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aixaDeTexto 17"/>
            <p:cNvSpPr txBox="1"/>
            <p:nvPr/>
          </p:nvSpPr>
          <p:spPr>
            <a:xfrm>
              <a:off x="3000124" y="9472090"/>
              <a:ext cx="872355" cy="3347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575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5 </a:t>
              </a:r>
              <a:r>
                <a:rPr lang="pt-BR" sz="1575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ays</a:t>
              </a:r>
              <a:endParaRPr lang="pt-BR" sz="1575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" name="Conector reto 21"/>
            <p:cNvCxnSpPr/>
            <p:nvPr/>
          </p:nvCxnSpPr>
          <p:spPr>
            <a:xfrm>
              <a:off x="875644" y="11684542"/>
              <a:ext cx="445275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ector de seta reta 25"/>
            <p:cNvCxnSpPr/>
            <p:nvPr/>
          </p:nvCxnSpPr>
          <p:spPr>
            <a:xfrm>
              <a:off x="890340" y="11699238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Conector de seta reta 27"/>
            <p:cNvCxnSpPr/>
            <p:nvPr/>
          </p:nvCxnSpPr>
          <p:spPr>
            <a:xfrm>
              <a:off x="3013817" y="11708018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de seta reta 28"/>
            <p:cNvCxnSpPr/>
            <p:nvPr/>
          </p:nvCxnSpPr>
          <p:spPr>
            <a:xfrm>
              <a:off x="5321011" y="11677055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ector de seta reta 30"/>
            <p:cNvCxnSpPr/>
            <p:nvPr/>
          </p:nvCxnSpPr>
          <p:spPr>
            <a:xfrm>
              <a:off x="1743595" y="12900428"/>
              <a:ext cx="620867" cy="644398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ector de seta reta 33"/>
            <p:cNvCxnSpPr/>
            <p:nvPr/>
          </p:nvCxnSpPr>
          <p:spPr>
            <a:xfrm>
              <a:off x="3056343" y="13110404"/>
              <a:ext cx="0" cy="434421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ctor de seta reta 38"/>
            <p:cNvCxnSpPr/>
            <p:nvPr/>
          </p:nvCxnSpPr>
          <p:spPr>
            <a:xfrm flipH="1">
              <a:off x="3897150" y="12916574"/>
              <a:ext cx="486355" cy="628251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ector reto 44"/>
            <p:cNvCxnSpPr/>
            <p:nvPr/>
          </p:nvCxnSpPr>
          <p:spPr>
            <a:xfrm>
              <a:off x="2941339" y="7956160"/>
              <a:ext cx="675806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ector reto 45"/>
            <p:cNvCxnSpPr/>
            <p:nvPr/>
          </p:nvCxnSpPr>
          <p:spPr>
            <a:xfrm flipH="1">
              <a:off x="2938772" y="7970788"/>
              <a:ext cx="1" cy="29563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ector reto 46"/>
            <p:cNvCxnSpPr/>
            <p:nvPr/>
          </p:nvCxnSpPr>
          <p:spPr>
            <a:xfrm flipH="1">
              <a:off x="9671563" y="7937059"/>
              <a:ext cx="1" cy="29563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ector reto 55"/>
            <p:cNvCxnSpPr/>
            <p:nvPr/>
          </p:nvCxnSpPr>
          <p:spPr>
            <a:xfrm flipH="1">
              <a:off x="6183063" y="7673510"/>
              <a:ext cx="1" cy="29563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ector reto 56"/>
            <p:cNvCxnSpPr/>
            <p:nvPr/>
          </p:nvCxnSpPr>
          <p:spPr>
            <a:xfrm flipH="1">
              <a:off x="3022838" y="11429075"/>
              <a:ext cx="1" cy="29563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CaixaDeTexto 57"/>
            <p:cNvSpPr txBox="1"/>
            <p:nvPr/>
          </p:nvSpPr>
          <p:spPr>
            <a:xfrm>
              <a:off x="796765" y="14617190"/>
              <a:ext cx="4760342" cy="578620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icago Sky blue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ye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jection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o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 +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uthanasia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</a:t>
              </a:r>
            </a:p>
            <a:p>
              <a:pPr algn="ctr"/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ardial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fusion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0%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malin</a:t>
              </a:r>
              <a:endParaRPr lang="pt-BR" sz="158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794962" y="15674011"/>
              <a:ext cx="4785285" cy="578620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ains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rvested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posterior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stological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algn="ctr"/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jection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ites</a:t>
              </a:r>
              <a:endParaRPr lang="pt-BR" sz="158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Conector de seta reta 59"/>
            <p:cNvCxnSpPr/>
            <p:nvPr/>
          </p:nvCxnSpPr>
          <p:spPr>
            <a:xfrm>
              <a:off x="3087117" y="14250153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ector de seta reta 60"/>
            <p:cNvCxnSpPr/>
            <p:nvPr/>
          </p:nvCxnSpPr>
          <p:spPr>
            <a:xfrm>
              <a:off x="3128216" y="15273113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CaixaDeTexto 61"/>
            <p:cNvSpPr txBox="1"/>
            <p:nvPr/>
          </p:nvSpPr>
          <p:spPr>
            <a:xfrm>
              <a:off x="7832531" y="9311794"/>
              <a:ext cx="2941832" cy="578620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uthanasia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</a:t>
              </a:r>
            </a:p>
            <a:p>
              <a:pPr algn="ctr"/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ardial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fusion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aline</a:t>
              </a:r>
              <a:endParaRPr lang="pt-BR" sz="158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CaixaDeTexto 62"/>
            <p:cNvSpPr txBox="1"/>
            <p:nvPr/>
          </p:nvSpPr>
          <p:spPr>
            <a:xfrm>
              <a:off x="7224191" y="10244435"/>
              <a:ext cx="4158511" cy="578620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ains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re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arvested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zen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n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quid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itrogen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</a:p>
            <a:p>
              <a:pPr algn="ctr"/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ored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</a:t>
              </a:r>
              <a:r>
                <a:rPr lang="pt-BR" sz="158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-80º C</a:t>
              </a:r>
              <a:endParaRPr lang="pt-BR" sz="158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CaixaDeTexto 63"/>
            <p:cNvSpPr txBox="1"/>
            <p:nvPr/>
          </p:nvSpPr>
          <p:spPr>
            <a:xfrm>
              <a:off x="7938507" y="11177076"/>
              <a:ext cx="2855018" cy="579261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ropunch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echnique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btaining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s</a:t>
              </a:r>
              <a:endParaRPr lang="pt-BR" sz="15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CaixaDeTexto 64"/>
            <p:cNvSpPr txBox="1"/>
            <p:nvPr/>
          </p:nvSpPr>
          <p:spPr>
            <a:xfrm>
              <a:off x="6906093" y="12340884"/>
              <a:ext cx="2357377" cy="1066189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PCR</a:t>
              </a:r>
              <a:endParaRPr lang="pt-BR" sz="1582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gene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</a:t>
              </a:r>
              <a:endParaRPr lang="pt-BR" sz="1582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as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ceptors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endParaRPr lang="pt-BR" sz="1582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-2 in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urons</a:t>
              </a:r>
              <a:endParaRPr lang="pt-BR" sz="15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CaixaDeTexto 65"/>
            <p:cNvSpPr txBox="1"/>
            <p:nvPr/>
          </p:nvSpPr>
          <p:spPr>
            <a:xfrm>
              <a:off x="9633666" y="12340884"/>
              <a:ext cx="2281394" cy="130965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estern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otting</a:t>
              </a:r>
              <a:endParaRPr lang="pt-BR" sz="1582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valuation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</a:t>
              </a:r>
              <a:endParaRPr lang="pt-BR" sz="1582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pt-BR" sz="1582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tein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ression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</a:t>
              </a:r>
            </a:p>
            <a:p>
              <a:pPr algn="ctr"/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s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ceptors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E-2</a:t>
              </a:r>
            </a:p>
            <a:p>
              <a:pPr algn="ctr"/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</a:t>
              </a:r>
              <a:r>
                <a:rPr lang="pt-BR" sz="1582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PA </a:t>
              </a:r>
              <a:r>
                <a:rPr lang="pt-BR" sz="1582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urons</a:t>
              </a:r>
              <a:endParaRPr lang="pt-BR" sz="158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7" name="Conector reto 66"/>
            <p:cNvCxnSpPr/>
            <p:nvPr/>
          </p:nvCxnSpPr>
          <p:spPr>
            <a:xfrm flipH="1">
              <a:off x="9366016" y="11764852"/>
              <a:ext cx="1" cy="295633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ector reto 70"/>
            <p:cNvCxnSpPr/>
            <p:nvPr/>
          </p:nvCxnSpPr>
          <p:spPr>
            <a:xfrm>
              <a:off x="7938507" y="12033294"/>
              <a:ext cx="2855018" cy="814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ector de seta reta 71"/>
            <p:cNvCxnSpPr/>
            <p:nvPr/>
          </p:nvCxnSpPr>
          <p:spPr>
            <a:xfrm>
              <a:off x="7968267" y="12011474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ector de seta reta 74"/>
            <p:cNvCxnSpPr/>
            <p:nvPr/>
          </p:nvCxnSpPr>
          <p:spPr>
            <a:xfrm>
              <a:off x="10799589" y="12038888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ector de seta reta 75"/>
            <p:cNvCxnSpPr/>
            <p:nvPr/>
          </p:nvCxnSpPr>
          <p:spPr>
            <a:xfrm>
              <a:off x="9361322" y="9905627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ector de seta reta 76"/>
            <p:cNvCxnSpPr/>
            <p:nvPr/>
          </p:nvCxnSpPr>
          <p:spPr>
            <a:xfrm>
              <a:off x="9361322" y="10818538"/>
              <a:ext cx="4694" cy="323594"/>
            </a:xfrm>
            <a:prstGeom prst="straightConnector1">
              <a:avLst/>
            </a:prstGeom>
            <a:ln w="508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49" name="Conector de seta reta 48"/>
          <p:cNvCxnSpPr/>
          <p:nvPr/>
        </p:nvCxnSpPr>
        <p:spPr>
          <a:xfrm flipH="1">
            <a:off x="3014972" y="4592901"/>
            <a:ext cx="2" cy="269738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ector de seta reta 50"/>
          <p:cNvCxnSpPr/>
          <p:nvPr/>
        </p:nvCxnSpPr>
        <p:spPr>
          <a:xfrm>
            <a:off x="9379646" y="4619336"/>
            <a:ext cx="4694" cy="323594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75667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2</TotalTime>
  <Words>202</Words>
  <Application>Microsoft Office PowerPoint</Application>
  <PresentationFormat>Personalizar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ônica Sato</dc:creator>
  <cp:lastModifiedBy>Mônica Sato</cp:lastModifiedBy>
  <cp:revision>18</cp:revision>
  <dcterms:created xsi:type="dcterms:W3CDTF">2020-05-25T23:45:49Z</dcterms:created>
  <dcterms:modified xsi:type="dcterms:W3CDTF">2021-06-28T15:35:38Z</dcterms:modified>
</cp:coreProperties>
</file>